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288FB65-16ED-4A19-900E-9AD39EAAF547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12756DA-AA18-47E5-ACCD-5B2D07018704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E0C19FF-23C6-4379-B3C5-E029E8AF420E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9B62703-8ECE-4B2F-9D7E-BAE2E62E70C7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FF9A374-BEB3-49FC-8B45-7849DD137074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C4D03FC-44A5-4D2A-A45A-C68AD43DCD5D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9732B09-723E-433C-BE4C-EF8139106B17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F82C8AA-683B-438C-A10A-003A555F973F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37BF9F1-2644-4A8D-BC05-57F043147696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10E1DEE-5A4D-43DC-B772-BA596C9E7BB2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CE953D0-B709-4814-93A6-7EDD27CDE0FA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39DF763-FE5D-47C5-B226-D6F8C1FAFF61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5720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245280"/>
            <a:ext cx="289584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6552720" y="6245280"/>
            <a:ext cx="21322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es-ES" sz="1800" spc="-1" strike="noStrike">
                <a:solidFill>
                  <a:srgbClr val="000000"/>
                </a:solidFill>
                <a:latin typeface="Arial"/>
                <a:ea typeface="Arial Unicode M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29FDE369-441D-4142-9429-7CE1E437183D}" type="slidenum">
              <a:rPr b="0" lang="es-ES" sz="1800" spc="-1" strike="noStrike">
                <a:solidFill>
                  <a:srgbClr val="000000"/>
                </a:solidFill>
                <a:latin typeface="Arial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348000" y="1917720"/>
            <a:ext cx="2664000" cy="27352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772720" y="2924280"/>
            <a:ext cx="56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773440" y="234936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GATA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54520" y="1784520"/>
            <a:ext cx="67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575240" y="1773360"/>
            <a:ext cx="7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KNK437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50 m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377880" y="549360"/>
            <a:ext cx="172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Additional fil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258920" y="4222800"/>
            <a:ext cx="6300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dditional file 6 :Figure S1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Western blot of GATA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. GATA1 WB from HEL cell lin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with and without KNK437 treatment (50 mcM). Actin was used as the housekeeping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18T13:59:45Z</dcterms:created>
  <dc:creator>HOSPITAL 12 DE OCTUBRE</dc:creator>
  <dc:description/>
  <dc:language>en-US</dc:language>
  <cp:lastModifiedBy>Gallardo</cp:lastModifiedBy>
  <dcterms:modified xsi:type="dcterms:W3CDTF">2012-08-01T17:16:21Z</dcterms:modified>
  <cp:revision>4</cp:revision>
  <dc:subject/>
  <dc:title>Diapositiva 1</dc:title>
</cp:coreProperties>
</file>